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721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414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1543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1848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3485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4263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9816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6508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0778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9500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58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9068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5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4989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AB96917F-AEE7-482D-8B3C-CDBB205B09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515195"/>
            <a:ext cx="6858000" cy="4875609"/>
          </a:xfrm>
          <a:prstGeom prst="rect">
            <a:avLst/>
          </a:prstGeom>
        </p:spPr>
      </p:pic>
      <p:sp>
        <p:nvSpPr>
          <p:cNvPr id="3" name="직사각형 2">
            <a:extLst>
              <a:ext uri="{FF2B5EF4-FFF2-40B4-BE49-F238E27FC236}">
                <a16:creationId xmlns:a16="http://schemas.microsoft.com/office/drawing/2014/main" id="{C8AEE635-9848-4F79-AD9B-EFF16F2E265F}"/>
              </a:ext>
            </a:extLst>
          </p:cNvPr>
          <p:cNvSpPr/>
          <p:nvPr/>
        </p:nvSpPr>
        <p:spPr>
          <a:xfrm>
            <a:off x="158153" y="7280022"/>
            <a:ext cx="6541694" cy="5263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000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. Total isoflavone content in seeds of Hwanggeum and DB-088 according to developmental stages. *, **, and *** indicate significance at </a:t>
            </a:r>
            <a:r>
              <a:rPr lang="en-US" altLang="ko-KR" sz="1000" i="1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5, 0.01, and 0.001, respectively</a:t>
            </a:r>
            <a:endParaRPr lang="ko-KR" altLang="ko-KR" sz="1000" kern="1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7110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7</TotalTime>
  <Words>34</Words>
  <Application>Microsoft Office PowerPoint</Application>
  <PresentationFormat>A4 용지(210x297mm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정민/원급(외부)/방사선육종연구실</dc:creator>
  <cp:lastModifiedBy>김정민/선임급(외부)/방사선육종연구실</cp:lastModifiedBy>
  <cp:revision>15</cp:revision>
  <dcterms:created xsi:type="dcterms:W3CDTF">2023-01-19T01:34:14Z</dcterms:created>
  <dcterms:modified xsi:type="dcterms:W3CDTF">2023-09-03T09:15:42Z</dcterms:modified>
</cp:coreProperties>
</file>